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51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5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512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14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898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332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73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114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04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998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96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815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130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787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Picture 2">
            <a:extLst>
              <a:ext uri="{FF2B5EF4-FFF2-40B4-BE49-F238E27FC236}">
                <a16:creationId xmlns:a16="http://schemas.microsoft.com/office/drawing/2014/main" xmlns="" id="{0911EE4E-277B-9D47-B25B-821025C4AD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10740" t="1729" r="40334" b="5927"/>
          <a:stretch/>
        </p:blipFill>
        <p:spPr bwMode="auto">
          <a:xfrm>
            <a:off x="2186578" y="2121452"/>
            <a:ext cx="1139101" cy="12224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1" name="Picture 5">
            <a:extLst>
              <a:ext uri="{FF2B5EF4-FFF2-40B4-BE49-F238E27FC236}">
                <a16:creationId xmlns:a16="http://schemas.microsoft.com/office/drawing/2014/main" xmlns="" id="{E408216E-1061-3043-A7D7-DE75E1A7D3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/>
          <a:srcRect l="8695" t="1" r="42030" b="5691"/>
          <a:stretch/>
        </p:blipFill>
        <p:spPr bwMode="auto">
          <a:xfrm>
            <a:off x="716333" y="2105851"/>
            <a:ext cx="1160092" cy="12624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3826CC5C-E56C-C24B-8A87-1C2A08ABA37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252" r="44066" b="5488"/>
          <a:stretch/>
        </p:blipFill>
        <p:spPr>
          <a:xfrm>
            <a:off x="551141" y="717271"/>
            <a:ext cx="1125483" cy="97926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39496153-D4DE-954F-B02B-B1DEC886218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t="1615" r="43111" b="5218"/>
          <a:stretch/>
        </p:blipFill>
        <p:spPr>
          <a:xfrm>
            <a:off x="1754495" y="733764"/>
            <a:ext cx="1093920" cy="97381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E9B29977-AA65-7043-9262-BE28666DED2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-737" r="42098" b="3094"/>
          <a:stretch/>
        </p:blipFill>
        <p:spPr>
          <a:xfrm>
            <a:off x="2966858" y="717271"/>
            <a:ext cx="1107813" cy="98471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4F711CDD-9A69-6141-A745-8EABD9130AA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213" r="42447" b="4854"/>
          <a:stretch/>
        </p:blipFill>
        <p:spPr>
          <a:xfrm>
            <a:off x="4074671" y="733764"/>
            <a:ext cx="1085691" cy="969805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xmlns="" id="{5C3324E6-749A-E748-95B0-0AFF3936201A}"/>
              </a:ext>
            </a:extLst>
          </p:cNvPr>
          <p:cNvGrpSpPr/>
          <p:nvPr/>
        </p:nvGrpSpPr>
        <p:grpSpPr>
          <a:xfrm>
            <a:off x="5275450" y="711988"/>
            <a:ext cx="1018665" cy="592148"/>
            <a:chOff x="3189795" y="2652095"/>
            <a:chExt cx="1103553" cy="641495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5E8AEDE8-4CC5-F04E-9E45-752193367A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1601" t="17582" r="36614" b="78635"/>
            <a:stretch/>
          </p:blipFill>
          <p:spPr>
            <a:xfrm>
              <a:off x="3196900" y="3149219"/>
              <a:ext cx="108298" cy="117079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B1872932-E46E-9046-B2F8-3183C210C6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1664" t="12379" r="36645" b="83648"/>
            <a:stretch/>
          </p:blipFill>
          <p:spPr>
            <a:xfrm>
              <a:off x="3199785" y="2989354"/>
              <a:ext cx="102526" cy="122934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88182211-FECE-1547-8043-D886FD6AFE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1601" t="27543" r="36614" b="68696"/>
            <a:stretch/>
          </p:blipFill>
          <p:spPr>
            <a:xfrm>
              <a:off x="3196900" y="2851534"/>
              <a:ext cx="108298" cy="116381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FDFBF33C-666C-6D45-AC16-D6A33D6F66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61503" t="22426" r="36477" b="73714"/>
            <a:stretch/>
          </p:blipFill>
          <p:spPr>
            <a:xfrm>
              <a:off x="3189795" y="2700019"/>
              <a:ext cx="122507" cy="119443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DD09BE54-8543-F94C-A0D1-7DA452D6019E}"/>
                </a:ext>
              </a:extLst>
            </p:cNvPr>
            <p:cNvSpPr txBox="1"/>
            <p:nvPr/>
          </p:nvSpPr>
          <p:spPr>
            <a:xfrm>
              <a:off x="3251048" y="2652095"/>
              <a:ext cx="714084" cy="1922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3" dirty="0"/>
                <a:t>WT (Uninfected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438BB1A7-C522-C34B-A708-DA4511AC31FB}"/>
                </a:ext>
              </a:extLst>
            </p:cNvPr>
            <p:cNvSpPr txBox="1"/>
            <p:nvPr/>
          </p:nvSpPr>
          <p:spPr>
            <a:xfrm>
              <a:off x="3251048" y="2806261"/>
              <a:ext cx="828699" cy="1922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3" i="1" dirty="0"/>
                <a:t>Mavs</a:t>
              </a:r>
              <a:r>
                <a:rPr lang="en-US" sz="553" i="1" baseline="30000" dirty="0"/>
                <a:t>-/-</a:t>
              </a:r>
              <a:r>
                <a:rPr lang="en-US" sz="553" i="1" dirty="0"/>
                <a:t> </a:t>
              </a:r>
              <a:r>
                <a:rPr lang="en-US" sz="553" dirty="0"/>
                <a:t>(Uninfected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279CEEA3-D81D-E043-8A95-3D9BF2DA4BE3}"/>
                </a:ext>
              </a:extLst>
            </p:cNvPr>
            <p:cNvSpPr txBox="1"/>
            <p:nvPr/>
          </p:nvSpPr>
          <p:spPr>
            <a:xfrm>
              <a:off x="3251048" y="2957852"/>
              <a:ext cx="927685" cy="1922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3" dirty="0"/>
                <a:t>WT (</a:t>
              </a:r>
              <a:r>
                <a:rPr lang="en-US" sz="553" i="1" dirty="0" err="1"/>
                <a:t>M.avium</a:t>
              </a:r>
              <a:r>
                <a:rPr lang="en-US" sz="553" dirty="0"/>
                <a:t>-infected)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0DC51773-964D-E144-9921-27BB5259D2AC}"/>
                </a:ext>
              </a:extLst>
            </p:cNvPr>
            <p:cNvSpPr txBox="1"/>
            <p:nvPr/>
          </p:nvSpPr>
          <p:spPr>
            <a:xfrm>
              <a:off x="3251048" y="3101384"/>
              <a:ext cx="1042300" cy="1922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3" i="1" dirty="0"/>
                <a:t>Mavs</a:t>
              </a:r>
              <a:r>
                <a:rPr lang="en-US" sz="553" i="1" baseline="30000" dirty="0"/>
                <a:t>-/-</a:t>
              </a:r>
              <a:r>
                <a:rPr lang="en-US" sz="553" i="1" dirty="0"/>
                <a:t> </a:t>
              </a:r>
              <a:r>
                <a:rPr lang="en-US" sz="553" dirty="0"/>
                <a:t>(</a:t>
              </a:r>
              <a:r>
                <a:rPr lang="en-US" sz="553" i="1" dirty="0" err="1"/>
                <a:t>M.avium</a:t>
              </a:r>
              <a:r>
                <a:rPr lang="en-US" sz="553" dirty="0"/>
                <a:t>-infected)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9329DEB6-089D-CF43-A757-A564CA624C60}"/>
              </a:ext>
            </a:extLst>
          </p:cNvPr>
          <p:cNvSpPr txBox="1"/>
          <p:nvPr/>
        </p:nvSpPr>
        <p:spPr>
          <a:xfrm>
            <a:off x="1055380" y="570107"/>
            <a:ext cx="348172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DC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E6251EC5-B2B9-9E4B-A0A3-F271F6CAAD60}"/>
              </a:ext>
            </a:extLst>
          </p:cNvPr>
          <p:cNvSpPr txBox="1"/>
          <p:nvPr/>
        </p:nvSpPr>
        <p:spPr>
          <a:xfrm>
            <a:off x="2033848" y="570107"/>
            <a:ext cx="69281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Neutrophil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956FBD86-168A-914E-9263-3E5DBCA5C237}"/>
              </a:ext>
            </a:extLst>
          </p:cNvPr>
          <p:cNvSpPr txBox="1"/>
          <p:nvPr/>
        </p:nvSpPr>
        <p:spPr>
          <a:xfrm>
            <a:off x="3259756" y="570407"/>
            <a:ext cx="65915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CD4 T Cell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C13C4282-D942-7147-A136-CE2531DE05A8}"/>
              </a:ext>
            </a:extLst>
          </p:cNvPr>
          <p:cNvSpPr txBox="1"/>
          <p:nvPr/>
        </p:nvSpPr>
        <p:spPr>
          <a:xfrm>
            <a:off x="4415985" y="570407"/>
            <a:ext cx="65915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CD8 T Cell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8A51078B-067D-554D-869A-2BABDD0F559D}"/>
              </a:ext>
            </a:extLst>
          </p:cNvPr>
          <p:cNvSpPr txBox="1"/>
          <p:nvPr/>
        </p:nvSpPr>
        <p:spPr>
          <a:xfrm>
            <a:off x="966801" y="1930115"/>
            <a:ext cx="65915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CD4 T Cell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D958F23D-A33A-1442-9F6F-7EF6ACBB3D7B}"/>
              </a:ext>
            </a:extLst>
          </p:cNvPr>
          <p:cNvSpPr txBox="1"/>
          <p:nvPr/>
        </p:nvSpPr>
        <p:spPr>
          <a:xfrm>
            <a:off x="2426551" y="1930115"/>
            <a:ext cx="65915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31" dirty="0"/>
              <a:t>CD8 T Cell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173F6B6D-19EB-6D4E-9987-D4E3EB99EEC9}"/>
              </a:ext>
            </a:extLst>
          </p:cNvPr>
          <p:cNvSpPr txBox="1"/>
          <p:nvPr/>
        </p:nvSpPr>
        <p:spPr>
          <a:xfrm>
            <a:off x="982831" y="3316661"/>
            <a:ext cx="627095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FN-</a:t>
            </a:r>
            <a:r>
              <a:rPr lang="el-GR" sz="739" dirty="0"/>
              <a:t>γ</a:t>
            </a:r>
            <a:r>
              <a:rPr lang="en-US" sz="739" dirty="0"/>
              <a:t> (FITC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81CD6568-BD72-A244-9D58-AE07741A310C}"/>
              </a:ext>
            </a:extLst>
          </p:cNvPr>
          <p:cNvSpPr txBox="1"/>
          <p:nvPr/>
        </p:nvSpPr>
        <p:spPr>
          <a:xfrm>
            <a:off x="2442580" y="3316661"/>
            <a:ext cx="627095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FN-</a:t>
            </a:r>
            <a:r>
              <a:rPr lang="el-GR" sz="739" dirty="0"/>
              <a:t>γ</a:t>
            </a:r>
            <a:r>
              <a:rPr lang="en-US" sz="739" dirty="0"/>
              <a:t> (FITC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D0121D2A-E392-3D41-9173-F22C43FFCA20}"/>
              </a:ext>
            </a:extLst>
          </p:cNvPr>
          <p:cNvSpPr txBox="1"/>
          <p:nvPr/>
        </p:nvSpPr>
        <p:spPr>
          <a:xfrm>
            <a:off x="875498" y="1649844"/>
            <a:ext cx="716863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CAM-1 (FITC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D4AEC1F8-9934-B248-964F-FB0C915396C1}"/>
              </a:ext>
            </a:extLst>
          </p:cNvPr>
          <p:cNvSpPr txBox="1"/>
          <p:nvPr/>
        </p:nvSpPr>
        <p:spPr>
          <a:xfrm>
            <a:off x="2049597" y="1649844"/>
            <a:ext cx="716863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CAM-1 (FITC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2073FED1-D238-8F41-AC19-3B79FDE4DD1C}"/>
              </a:ext>
            </a:extLst>
          </p:cNvPr>
          <p:cNvSpPr txBox="1"/>
          <p:nvPr/>
        </p:nvSpPr>
        <p:spPr>
          <a:xfrm>
            <a:off x="3239070" y="1649844"/>
            <a:ext cx="716863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CAM-1 (FITC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A1BC5FA5-8A92-7B4E-B064-8DC178B57257}"/>
              </a:ext>
            </a:extLst>
          </p:cNvPr>
          <p:cNvSpPr txBox="1"/>
          <p:nvPr/>
        </p:nvSpPr>
        <p:spPr>
          <a:xfrm>
            <a:off x="4383506" y="1649844"/>
            <a:ext cx="716863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CAM-1 (FITC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9B619E4B-0F65-FC44-83E2-CA3D2F5E6240}"/>
              </a:ext>
            </a:extLst>
          </p:cNvPr>
          <p:cNvSpPr txBox="1"/>
          <p:nvPr/>
        </p:nvSpPr>
        <p:spPr>
          <a:xfrm>
            <a:off x="409691" y="5663847"/>
            <a:ext cx="6064080" cy="1967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8" b="1" dirty="0"/>
              <a:t>S2 Fig. Flow cytometry and ELISA analysis for cytokine production in immune cells and mice post </a:t>
            </a:r>
            <a:r>
              <a:rPr lang="en-US" sz="1108" b="1" i="1" dirty="0" err="1"/>
              <a:t>M.avium</a:t>
            </a:r>
            <a:r>
              <a:rPr lang="en-US" sz="1108" b="1" i="1" dirty="0"/>
              <a:t> </a:t>
            </a:r>
            <a:r>
              <a:rPr lang="en-US" sz="1108" b="1" dirty="0"/>
              <a:t>infection.</a:t>
            </a:r>
          </a:p>
          <a:p>
            <a:pPr marL="211008" indent="-211008">
              <a:buAutoNum type="alphaUcParenR"/>
            </a:pPr>
            <a:r>
              <a:rPr lang="en-US" sz="1108" dirty="0"/>
              <a:t>Flow cytometry analysis for ICAM-1 production on lung immune cells isolated from WT and </a:t>
            </a:r>
            <a:r>
              <a:rPr lang="en-US" sz="1108" i="1" dirty="0"/>
              <a:t>Mavs</a:t>
            </a:r>
            <a:r>
              <a:rPr lang="en-US" sz="1108" i="1" baseline="30000" dirty="0"/>
              <a:t>-/- </a:t>
            </a:r>
            <a:r>
              <a:rPr lang="en-US" sz="1108" dirty="0"/>
              <a:t>mice infected with WT </a:t>
            </a:r>
            <a:r>
              <a:rPr lang="en-US" sz="1108" i="1" dirty="0" err="1"/>
              <a:t>M.avium</a:t>
            </a:r>
            <a:r>
              <a:rPr lang="en-US" sz="1108" i="1" dirty="0"/>
              <a:t> </a:t>
            </a:r>
            <a:r>
              <a:rPr lang="en-US" sz="1108" dirty="0"/>
              <a:t>for 3 weeks. </a:t>
            </a:r>
          </a:p>
          <a:p>
            <a:pPr marL="211008" indent="-211008">
              <a:buAutoNum type="alphaUcParenR"/>
            </a:pPr>
            <a:r>
              <a:rPr lang="en-US" sz="1108" dirty="0"/>
              <a:t>Similar to A), but IFN-</a:t>
            </a:r>
            <a:r>
              <a:rPr lang="el-GR" sz="1108" dirty="0"/>
              <a:t>γ</a:t>
            </a:r>
            <a:r>
              <a:rPr lang="en-US" sz="1108" dirty="0"/>
              <a:t> production on CD4</a:t>
            </a:r>
            <a:r>
              <a:rPr lang="en-US" sz="1108" baseline="30000" dirty="0"/>
              <a:t>+</a:t>
            </a:r>
            <a:r>
              <a:rPr lang="en-US" sz="1108" dirty="0"/>
              <a:t> and CD8</a:t>
            </a:r>
            <a:r>
              <a:rPr lang="en-US" sz="1108" baseline="30000" dirty="0"/>
              <a:t>+</a:t>
            </a:r>
            <a:r>
              <a:rPr lang="en-US" sz="1108" dirty="0"/>
              <a:t> T cells.</a:t>
            </a:r>
          </a:p>
          <a:p>
            <a:pPr marL="211008" indent="-211008">
              <a:buAutoNum type="alphaUcParenR"/>
            </a:pPr>
            <a:r>
              <a:rPr lang="en-US" sz="1108" dirty="0"/>
              <a:t>ELISA analysis for IFN-</a:t>
            </a:r>
            <a:r>
              <a:rPr lang="el-GR" sz="1108" dirty="0"/>
              <a:t>γ</a:t>
            </a:r>
            <a:r>
              <a:rPr lang="en-US" sz="1108" dirty="0"/>
              <a:t> production in mouse lung after 3 weeks post </a:t>
            </a:r>
            <a:r>
              <a:rPr lang="en-US" sz="1108" i="1" dirty="0" err="1"/>
              <a:t>M.avium</a:t>
            </a:r>
            <a:r>
              <a:rPr lang="en-US" sz="1108" i="1" dirty="0"/>
              <a:t> </a:t>
            </a:r>
            <a:r>
              <a:rPr lang="en-US" sz="1108" dirty="0"/>
              <a:t>infection. The data shown is the combination of three independent experiments (biological repeats). n=3 per group each experiment. </a:t>
            </a:r>
            <a:r>
              <a:rPr lang="en-US" sz="1108" dirty="0" err="1"/>
              <a:t>n.s</a:t>
            </a:r>
            <a:r>
              <a:rPr lang="en-US" sz="1108" dirty="0"/>
              <a:t>., not statistically significant by Mann–Whitney U test.</a:t>
            </a:r>
          </a:p>
          <a:p>
            <a:pPr marL="211008" indent="-211008">
              <a:buAutoNum type="alphaUcParenR"/>
            </a:pPr>
            <a:r>
              <a:rPr lang="en-US" sz="1108" dirty="0"/>
              <a:t>MHCII, CD80, CD86 and CD40 abundance on WT and </a:t>
            </a:r>
            <a:r>
              <a:rPr lang="en-US" sz="1108" i="1" dirty="0"/>
              <a:t>Mavs</a:t>
            </a:r>
            <a:r>
              <a:rPr lang="en-US" sz="1108" i="1" baseline="30000" dirty="0"/>
              <a:t>-/- </a:t>
            </a:r>
            <a:r>
              <a:rPr lang="en-US" sz="1108" dirty="0"/>
              <a:t>BMMs infected with </a:t>
            </a:r>
            <a:r>
              <a:rPr lang="en-US" sz="1108" i="1" dirty="0" err="1"/>
              <a:t>M.avium</a:t>
            </a:r>
            <a:r>
              <a:rPr lang="en-US" sz="1108" i="1" dirty="0"/>
              <a:t> </a:t>
            </a:r>
            <a:r>
              <a:rPr lang="en-US" sz="1108" dirty="0"/>
              <a:t>at 24 </a:t>
            </a:r>
            <a:r>
              <a:rPr lang="en-US" sz="1108" dirty="0" err="1"/>
              <a:t>hr</a:t>
            </a:r>
            <a:r>
              <a:rPr lang="en-US" sz="1108" dirty="0"/>
              <a:t> post infection.</a:t>
            </a:r>
          </a:p>
          <a:p>
            <a:r>
              <a:rPr lang="en-US" sz="1108" dirty="0"/>
              <a:t>      Data shown in A, B and D are representative of at least three independent experiments. 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xmlns="" id="{4B0D28A4-04D6-8E49-BBDB-5E3CC1706C26}"/>
              </a:ext>
            </a:extLst>
          </p:cNvPr>
          <p:cNvGrpSpPr/>
          <p:nvPr/>
        </p:nvGrpSpPr>
        <p:grpSpPr>
          <a:xfrm>
            <a:off x="489747" y="3549443"/>
            <a:ext cx="1434904" cy="1604308"/>
            <a:chOff x="306717" y="4678182"/>
            <a:chExt cx="1554480" cy="1738001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xmlns="" id="{E0AF86F1-E628-B54D-AE80-DF214F44819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/>
            <a:srcRect r="43382" b="13277"/>
            <a:stretch/>
          </p:blipFill>
          <p:spPr>
            <a:xfrm>
              <a:off x="306717" y="4678182"/>
              <a:ext cx="1554480" cy="1554480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xmlns="" id="{4B061550-BA91-4B49-BD3D-D85763EDE134}"/>
                </a:ext>
              </a:extLst>
            </p:cNvPr>
            <p:cNvSpPr txBox="1"/>
            <p:nvPr/>
          </p:nvSpPr>
          <p:spPr>
            <a:xfrm>
              <a:off x="803940" y="6192927"/>
              <a:ext cx="777464" cy="223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39" dirty="0"/>
                <a:t>MHC-II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xmlns="" id="{B574903F-1A65-6148-BEE3-116D677E808C}"/>
                </a:ext>
              </a:extLst>
            </p:cNvPr>
            <p:cNvSpPr txBox="1"/>
            <p:nvPr/>
          </p:nvSpPr>
          <p:spPr>
            <a:xfrm>
              <a:off x="1047140" y="4922618"/>
              <a:ext cx="770850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Uninfected)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9F6497E1-E46A-AB41-8680-B41BDE8B4154}"/>
                </a:ext>
              </a:extLst>
            </p:cNvPr>
            <p:cNvSpPr txBox="1"/>
            <p:nvPr/>
          </p:nvSpPr>
          <p:spPr>
            <a:xfrm>
              <a:off x="948412" y="5191585"/>
              <a:ext cx="869578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Uninfected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B5943D2D-A518-F942-B8DD-51EEB1A630C7}"/>
                </a:ext>
              </a:extLst>
            </p:cNvPr>
            <p:cNvSpPr txBox="1"/>
            <p:nvPr/>
          </p:nvSpPr>
          <p:spPr>
            <a:xfrm>
              <a:off x="459464" y="5516162"/>
              <a:ext cx="724742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35CCE9C3-9F04-E14B-9F1D-11232BABA803}"/>
                </a:ext>
              </a:extLst>
            </p:cNvPr>
            <p:cNvSpPr txBox="1"/>
            <p:nvPr/>
          </p:nvSpPr>
          <p:spPr>
            <a:xfrm>
              <a:off x="459464" y="5787422"/>
              <a:ext cx="781297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xmlns="" id="{0CF904CA-8444-BD49-ADB8-9A7C326B35BF}"/>
              </a:ext>
            </a:extLst>
          </p:cNvPr>
          <p:cNvGrpSpPr/>
          <p:nvPr/>
        </p:nvGrpSpPr>
        <p:grpSpPr>
          <a:xfrm>
            <a:off x="1930656" y="3643464"/>
            <a:ext cx="1373737" cy="1510288"/>
            <a:chOff x="1876167" y="4780037"/>
            <a:chExt cx="1488215" cy="1636146"/>
          </a:xfrm>
        </p:grpSpPr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xmlns="" id="{8012FD38-05E6-0146-950E-132A0ECF2D4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/>
            <a:srcRect l="1" t="5845" r="44452" b="14013"/>
            <a:stretch/>
          </p:blipFill>
          <p:spPr>
            <a:xfrm>
              <a:off x="1876167" y="4780037"/>
              <a:ext cx="1488215" cy="1446758"/>
            </a:xfrm>
            <a:prstGeom prst="rect">
              <a:avLst/>
            </a:prstGeom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1A57EB07-4BBC-F849-B1F9-B0B5F7E78AA4}"/>
                </a:ext>
              </a:extLst>
            </p:cNvPr>
            <p:cNvSpPr txBox="1"/>
            <p:nvPr/>
          </p:nvSpPr>
          <p:spPr>
            <a:xfrm>
              <a:off x="2593531" y="4922617"/>
              <a:ext cx="77085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Uninfected)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B6D9EFE6-30E9-B049-8CEA-6A6DB2C879D3}"/>
                </a:ext>
              </a:extLst>
            </p:cNvPr>
            <p:cNvSpPr txBox="1"/>
            <p:nvPr/>
          </p:nvSpPr>
          <p:spPr>
            <a:xfrm>
              <a:off x="2494804" y="5191585"/>
              <a:ext cx="869578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Uninfected)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BE274EAB-5769-6F4E-A015-49C504D21A62}"/>
                </a:ext>
              </a:extLst>
            </p:cNvPr>
            <p:cNvSpPr txBox="1"/>
            <p:nvPr/>
          </p:nvSpPr>
          <p:spPr>
            <a:xfrm>
              <a:off x="2031257" y="5516163"/>
              <a:ext cx="72474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A9C2F42B-0528-0E43-AFA9-78BEEC8164A6}"/>
                </a:ext>
              </a:extLst>
            </p:cNvPr>
            <p:cNvSpPr txBox="1"/>
            <p:nvPr/>
          </p:nvSpPr>
          <p:spPr>
            <a:xfrm>
              <a:off x="2031257" y="5787420"/>
              <a:ext cx="781297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xmlns="" id="{EAFD393F-2689-AF4D-8B1B-62209C8C7A57}"/>
                </a:ext>
              </a:extLst>
            </p:cNvPr>
            <p:cNvSpPr txBox="1"/>
            <p:nvPr/>
          </p:nvSpPr>
          <p:spPr>
            <a:xfrm>
              <a:off x="2340615" y="6192927"/>
              <a:ext cx="777463" cy="223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39" dirty="0"/>
                <a:t>CD80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xmlns="" id="{B0536929-A488-964A-8685-759C32895916}"/>
              </a:ext>
            </a:extLst>
          </p:cNvPr>
          <p:cNvGrpSpPr/>
          <p:nvPr/>
        </p:nvGrpSpPr>
        <p:grpSpPr>
          <a:xfrm>
            <a:off x="3325678" y="3661495"/>
            <a:ext cx="1394255" cy="1492257"/>
            <a:chOff x="3319707" y="4799571"/>
            <a:chExt cx="1510442" cy="1616611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xmlns="" id="{A6F2232F-84A8-F146-815D-04C2CB9B600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1"/>
            <a:srcRect t="7130" r="44738" b="12728"/>
            <a:stretch/>
          </p:blipFill>
          <p:spPr>
            <a:xfrm>
              <a:off x="3319707" y="4799571"/>
              <a:ext cx="1500262" cy="1452625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41DFDF60-700C-3D44-AA57-A18EFF40EABA}"/>
                </a:ext>
              </a:extLst>
            </p:cNvPr>
            <p:cNvSpPr txBox="1"/>
            <p:nvPr/>
          </p:nvSpPr>
          <p:spPr>
            <a:xfrm>
              <a:off x="4059298" y="4922617"/>
              <a:ext cx="77085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Uninfected)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A722316D-C2A5-024A-871D-872A46449124}"/>
                </a:ext>
              </a:extLst>
            </p:cNvPr>
            <p:cNvSpPr txBox="1"/>
            <p:nvPr/>
          </p:nvSpPr>
          <p:spPr>
            <a:xfrm>
              <a:off x="3960571" y="5191585"/>
              <a:ext cx="869578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Uninfected)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C7952A92-0E78-B741-9FF2-AE6825AB1CE3}"/>
                </a:ext>
              </a:extLst>
            </p:cNvPr>
            <p:cNvSpPr txBox="1"/>
            <p:nvPr/>
          </p:nvSpPr>
          <p:spPr>
            <a:xfrm>
              <a:off x="3488557" y="5516161"/>
              <a:ext cx="72474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9BEB9F21-2BF1-FC42-BC5B-6DD0B2AE0647}"/>
                </a:ext>
              </a:extLst>
            </p:cNvPr>
            <p:cNvSpPr txBox="1"/>
            <p:nvPr/>
          </p:nvSpPr>
          <p:spPr>
            <a:xfrm>
              <a:off x="3488557" y="5787421"/>
              <a:ext cx="781297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xmlns="" id="{B5F7F8B0-0A0E-D141-A834-71DE81F40101}"/>
                </a:ext>
              </a:extLst>
            </p:cNvPr>
            <p:cNvSpPr txBox="1"/>
            <p:nvPr/>
          </p:nvSpPr>
          <p:spPr>
            <a:xfrm>
              <a:off x="3799644" y="6192927"/>
              <a:ext cx="777465" cy="2232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39" dirty="0"/>
                <a:t>CD86</a:t>
              </a:r>
            </a:p>
          </p:txBody>
        </p: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xmlns="" id="{0A60A377-279B-6F48-B32B-E671DD2F564E}"/>
              </a:ext>
            </a:extLst>
          </p:cNvPr>
          <p:cNvGrpSpPr/>
          <p:nvPr/>
        </p:nvGrpSpPr>
        <p:grpSpPr>
          <a:xfrm>
            <a:off x="4889156" y="3643464"/>
            <a:ext cx="1261840" cy="1510288"/>
            <a:chOff x="5081210" y="4780037"/>
            <a:chExt cx="1366993" cy="1636146"/>
          </a:xfrm>
        </p:grpSpPr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xmlns="" id="{0573BBDA-211F-494F-871A-26A31216D38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/>
            <a:srcRect l="6605" t="6225" r="44679" b="13027"/>
            <a:stretch/>
          </p:blipFill>
          <p:spPr>
            <a:xfrm>
              <a:off x="5101080" y="4780037"/>
              <a:ext cx="1342686" cy="1472159"/>
            </a:xfrm>
            <a:prstGeom prst="rect">
              <a:avLst/>
            </a:prstGeom>
          </p:spPr>
        </p:pic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xmlns="" id="{2755FFEB-5A0F-794B-AA8B-D5ACC8CC0A94}"/>
                </a:ext>
              </a:extLst>
            </p:cNvPr>
            <p:cNvSpPr txBox="1"/>
            <p:nvPr/>
          </p:nvSpPr>
          <p:spPr>
            <a:xfrm>
              <a:off x="5677352" y="4934510"/>
              <a:ext cx="77085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Uninfected)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xmlns="" id="{B4F9A4A6-5A79-D947-9284-C3B91DD90F84}"/>
                </a:ext>
              </a:extLst>
            </p:cNvPr>
            <p:cNvSpPr txBox="1"/>
            <p:nvPr/>
          </p:nvSpPr>
          <p:spPr>
            <a:xfrm>
              <a:off x="5578625" y="5203479"/>
              <a:ext cx="869578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Uninfected)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xmlns="" id="{738101AD-0FE3-204E-A0F8-9C9AD4B8DE7E}"/>
                </a:ext>
              </a:extLst>
            </p:cNvPr>
            <p:cNvSpPr txBox="1"/>
            <p:nvPr/>
          </p:nvSpPr>
          <p:spPr>
            <a:xfrm>
              <a:off x="5081210" y="5528056"/>
              <a:ext cx="724741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dirty="0"/>
                <a:t>WT 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xmlns="" id="{6D57DB77-89DE-A947-97AE-496F29E23AFD}"/>
                </a:ext>
              </a:extLst>
            </p:cNvPr>
            <p:cNvSpPr txBox="1"/>
            <p:nvPr/>
          </p:nvSpPr>
          <p:spPr>
            <a:xfrm>
              <a:off x="5081210" y="5799315"/>
              <a:ext cx="781297" cy="1768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461" i="1" dirty="0"/>
                <a:t>Mavs</a:t>
              </a:r>
              <a:r>
                <a:rPr lang="en-US" sz="461" i="1" baseline="30000" dirty="0"/>
                <a:t>-/-</a:t>
              </a:r>
              <a:r>
                <a:rPr lang="en-US" sz="461" i="1" dirty="0"/>
                <a:t> </a:t>
              </a:r>
              <a:r>
                <a:rPr lang="en-US" sz="461" dirty="0"/>
                <a:t>(</a:t>
              </a:r>
              <a:r>
                <a:rPr lang="en-US" sz="461" i="1" dirty="0" err="1"/>
                <a:t>M.avium</a:t>
              </a:r>
              <a:r>
                <a:rPr lang="en-US" sz="461" dirty="0"/>
                <a:t>)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xmlns="" id="{93B0A121-E295-7541-A0A6-B324D685636C}"/>
                </a:ext>
              </a:extLst>
            </p:cNvPr>
            <p:cNvSpPr txBox="1"/>
            <p:nvPr/>
          </p:nvSpPr>
          <p:spPr>
            <a:xfrm>
              <a:off x="5409092" y="6192927"/>
              <a:ext cx="777463" cy="2232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39" dirty="0"/>
                <a:t>CD40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4DC4A92C-B925-AC4D-B280-8C7B87626AE5}"/>
              </a:ext>
            </a:extLst>
          </p:cNvPr>
          <p:cNvSpPr txBox="1"/>
          <p:nvPr/>
        </p:nvSpPr>
        <p:spPr>
          <a:xfrm>
            <a:off x="420652" y="413539"/>
            <a:ext cx="280846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7679F4F-B75F-DE43-AEB3-25CEF362A35A}"/>
              </a:ext>
            </a:extLst>
          </p:cNvPr>
          <p:cNvSpPr txBox="1"/>
          <p:nvPr/>
        </p:nvSpPr>
        <p:spPr>
          <a:xfrm>
            <a:off x="420652" y="1806177"/>
            <a:ext cx="27443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B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68EEB78D-B1A5-5543-A20C-79B1D7A3CB9C}"/>
              </a:ext>
            </a:extLst>
          </p:cNvPr>
          <p:cNvSpPr txBox="1"/>
          <p:nvPr/>
        </p:nvSpPr>
        <p:spPr>
          <a:xfrm>
            <a:off x="420652" y="3507545"/>
            <a:ext cx="287258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D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190690A1-500A-6242-848A-2546F3E80372}"/>
              </a:ext>
            </a:extLst>
          </p:cNvPr>
          <p:cNvSpPr txBox="1"/>
          <p:nvPr/>
        </p:nvSpPr>
        <p:spPr>
          <a:xfrm>
            <a:off x="3480940" y="1854248"/>
            <a:ext cx="27283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92" dirty="0"/>
              <a:t>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1269736A-9AF6-8440-AE19-58BE85B1D91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19257" y="2159893"/>
            <a:ext cx="712609" cy="1039628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85F106CE-EC60-1746-BFEA-F89631A97FD6}"/>
              </a:ext>
            </a:extLst>
          </p:cNvPr>
          <p:cNvSpPr txBox="1"/>
          <p:nvPr/>
        </p:nvSpPr>
        <p:spPr>
          <a:xfrm rot="16200000">
            <a:off x="3502049" y="2475271"/>
            <a:ext cx="691215" cy="206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9" dirty="0"/>
              <a:t>IFN-</a:t>
            </a:r>
            <a:r>
              <a:rPr lang="el-GR" sz="739" dirty="0"/>
              <a:t>γ</a:t>
            </a:r>
            <a:r>
              <a:rPr lang="en-US" sz="739" dirty="0"/>
              <a:t> (</a:t>
            </a:r>
            <a:r>
              <a:rPr lang="en-US" sz="739" dirty="0" err="1"/>
              <a:t>pg</a:t>
            </a:r>
            <a:r>
              <a:rPr lang="en-US" sz="739" dirty="0"/>
              <a:t>/ml)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xmlns="" id="{153135DA-657A-6B42-874F-055E9232CF30}"/>
              </a:ext>
            </a:extLst>
          </p:cNvPr>
          <p:cNvCxnSpPr/>
          <p:nvPr/>
        </p:nvCxnSpPr>
        <p:spPr>
          <a:xfrm>
            <a:off x="4056197" y="3169487"/>
            <a:ext cx="211016" cy="0"/>
          </a:xfrm>
          <a:prstGeom prst="line">
            <a:avLst/>
          </a:prstGeom>
          <a:ln w="317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xmlns="" id="{3F3AE65D-D7AE-4143-AA0B-9BCF2A787209}"/>
              </a:ext>
            </a:extLst>
          </p:cNvPr>
          <p:cNvCxnSpPr/>
          <p:nvPr/>
        </p:nvCxnSpPr>
        <p:spPr>
          <a:xfrm>
            <a:off x="4329725" y="3169487"/>
            <a:ext cx="211016" cy="0"/>
          </a:xfrm>
          <a:prstGeom prst="line">
            <a:avLst/>
          </a:prstGeom>
          <a:ln w="317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DF635E81-0EBC-E04C-9F5F-4D25CB5DA72C}"/>
              </a:ext>
            </a:extLst>
          </p:cNvPr>
          <p:cNvSpPr txBox="1"/>
          <p:nvPr/>
        </p:nvSpPr>
        <p:spPr>
          <a:xfrm>
            <a:off x="3947800" y="3143371"/>
            <a:ext cx="447558" cy="16325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461" dirty="0"/>
              <a:t>Uninfected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5BA2459C-3D2B-9646-9A66-A4D0FA5E11EF}"/>
              </a:ext>
            </a:extLst>
          </p:cNvPr>
          <p:cNvSpPr txBox="1"/>
          <p:nvPr/>
        </p:nvSpPr>
        <p:spPr>
          <a:xfrm>
            <a:off x="4243391" y="3143369"/>
            <a:ext cx="396262" cy="16325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461" i="1" dirty="0" err="1"/>
              <a:t>M.avium</a:t>
            </a:r>
            <a:endParaRPr lang="en-US" sz="461" i="1" dirty="0"/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xmlns="" id="{5027B785-D7C2-E24D-9C58-ABFEFFB0EF14}"/>
              </a:ext>
            </a:extLst>
          </p:cNvPr>
          <p:cNvCxnSpPr/>
          <p:nvPr/>
        </p:nvCxnSpPr>
        <p:spPr>
          <a:xfrm>
            <a:off x="4357511" y="2309063"/>
            <a:ext cx="211016" cy="0"/>
          </a:xfrm>
          <a:prstGeom prst="line">
            <a:avLst/>
          </a:prstGeom>
          <a:ln w="317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xmlns="" id="{C8C54586-8397-9945-AF7D-B9E6CA9BD7F3}"/>
              </a:ext>
            </a:extLst>
          </p:cNvPr>
          <p:cNvSpPr txBox="1"/>
          <p:nvPr/>
        </p:nvSpPr>
        <p:spPr>
          <a:xfrm>
            <a:off x="4329808" y="2168385"/>
            <a:ext cx="266420" cy="16325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461" dirty="0" err="1"/>
              <a:t>n.s</a:t>
            </a:r>
            <a:r>
              <a:rPr lang="en-US" sz="461" dirty="0"/>
              <a:t>.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E9F4FB4F-AE3D-7A46-A18E-22F76E42C7C3}"/>
              </a:ext>
            </a:extLst>
          </p:cNvPr>
          <p:cNvSpPr txBox="1"/>
          <p:nvPr/>
        </p:nvSpPr>
        <p:spPr>
          <a:xfrm>
            <a:off x="1192842" y="2165727"/>
            <a:ext cx="711553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dirty="0"/>
              <a:t>WT (Uninfected)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xmlns="" id="{FCF98AB2-0045-A142-AF96-058487DEFCAF}"/>
              </a:ext>
            </a:extLst>
          </p:cNvPr>
          <p:cNvSpPr txBox="1"/>
          <p:nvPr/>
        </p:nvSpPr>
        <p:spPr>
          <a:xfrm>
            <a:off x="1101708" y="2445269"/>
            <a:ext cx="802688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i="1" dirty="0"/>
              <a:t>Mavs</a:t>
            </a:r>
            <a:r>
              <a:rPr lang="en-US" sz="461" i="1" baseline="30000" dirty="0"/>
              <a:t>-/-</a:t>
            </a:r>
            <a:r>
              <a:rPr lang="en-US" sz="461" i="1" dirty="0"/>
              <a:t> </a:t>
            </a:r>
            <a:r>
              <a:rPr lang="en-US" sz="461" dirty="0"/>
              <a:t>(Uninfected)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xmlns="" id="{547940A2-7370-8346-953E-A82621F93522}"/>
              </a:ext>
            </a:extLst>
          </p:cNvPr>
          <p:cNvSpPr txBox="1"/>
          <p:nvPr/>
        </p:nvSpPr>
        <p:spPr>
          <a:xfrm>
            <a:off x="650372" y="2713615"/>
            <a:ext cx="668992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dirty="0"/>
              <a:t>WT (</a:t>
            </a:r>
            <a:r>
              <a:rPr lang="en-US" sz="461" i="1" dirty="0" err="1"/>
              <a:t>M.avium</a:t>
            </a:r>
            <a:r>
              <a:rPr lang="en-US" sz="461" dirty="0"/>
              <a:t>)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xmlns="" id="{761DB5E2-D4B8-6C43-8353-41EED3FAD4DB}"/>
              </a:ext>
            </a:extLst>
          </p:cNvPr>
          <p:cNvSpPr txBox="1"/>
          <p:nvPr/>
        </p:nvSpPr>
        <p:spPr>
          <a:xfrm>
            <a:off x="650372" y="2987455"/>
            <a:ext cx="721197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i="1" dirty="0"/>
              <a:t>Mavs</a:t>
            </a:r>
            <a:r>
              <a:rPr lang="en-US" sz="461" i="1" baseline="30000" dirty="0"/>
              <a:t>-/-</a:t>
            </a:r>
            <a:r>
              <a:rPr lang="en-US" sz="461" i="1" dirty="0"/>
              <a:t> </a:t>
            </a:r>
            <a:r>
              <a:rPr lang="en-US" sz="461" dirty="0"/>
              <a:t>(</a:t>
            </a:r>
            <a:r>
              <a:rPr lang="en-US" sz="461" i="1" dirty="0" err="1"/>
              <a:t>M.avium</a:t>
            </a:r>
            <a:r>
              <a:rPr lang="en-US" sz="461" dirty="0"/>
              <a:t>)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xmlns="" id="{ACD422F4-FAF0-A74E-8FA6-8CE90AD1ADC4}"/>
              </a:ext>
            </a:extLst>
          </p:cNvPr>
          <p:cNvSpPr txBox="1"/>
          <p:nvPr/>
        </p:nvSpPr>
        <p:spPr>
          <a:xfrm>
            <a:off x="2592838" y="2158547"/>
            <a:ext cx="711553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dirty="0"/>
              <a:t>WT (Uninfected)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xmlns="" id="{9A0D3F9C-0525-074F-A338-3C15749EE6CA}"/>
              </a:ext>
            </a:extLst>
          </p:cNvPr>
          <p:cNvSpPr txBox="1"/>
          <p:nvPr/>
        </p:nvSpPr>
        <p:spPr>
          <a:xfrm>
            <a:off x="2501704" y="2430273"/>
            <a:ext cx="802688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i="1" dirty="0"/>
              <a:t>Mavs</a:t>
            </a:r>
            <a:r>
              <a:rPr lang="en-US" sz="461" i="1" baseline="30000" dirty="0"/>
              <a:t>-/-</a:t>
            </a:r>
            <a:r>
              <a:rPr lang="en-US" sz="461" i="1" dirty="0"/>
              <a:t> </a:t>
            </a:r>
            <a:r>
              <a:rPr lang="en-US" sz="461" dirty="0"/>
              <a:t>(Uninfected)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D8D1319B-7681-1A4A-BAA8-51DA9BE9BDA5}"/>
              </a:ext>
            </a:extLst>
          </p:cNvPr>
          <p:cNvSpPr txBox="1"/>
          <p:nvPr/>
        </p:nvSpPr>
        <p:spPr>
          <a:xfrm>
            <a:off x="2050368" y="2698619"/>
            <a:ext cx="668992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dirty="0"/>
              <a:t>WT (</a:t>
            </a:r>
            <a:r>
              <a:rPr lang="en-US" sz="461" i="1" dirty="0" err="1"/>
              <a:t>M.avium</a:t>
            </a:r>
            <a:r>
              <a:rPr lang="en-US" sz="461" dirty="0"/>
              <a:t>)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xmlns="" id="{10376937-034D-6A49-8AB1-FEC28872581D}"/>
              </a:ext>
            </a:extLst>
          </p:cNvPr>
          <p:cNvSpPr txBox="1"/>
          <p:nvPr/>
        </p:nvSpPr>
        <p:spPr>
          <a:xfrm>
            <a:off x="2050368" y="2964643"/>
            <a:ext cx="721197" cy="1632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461" i="1" dirty="0"/>
              <a:t>Mavs</a:t>
            </a:r>
            <a:r>
              <a:rPr lang="en-US" sz="461" i="1" baseline="30000" dirty="0"/>
              <a:t>-/-</a:t>
            </a:r>
            <a:r>
              <a:rPr lang="en-US" sz="461" i="1" dirty="0"/>
              <a:t> </a:t>
            </a:r>
            <a:r>
              <a:rPr lang="en-US" sz="461" dirty="0"/>
              <a:t>(</a:t>
            </a:r>
            <a:r>
              <a:rPr lang="en-US" sz="461" i="1" dirty="0" err="1"/>
              <a:t>M.avium</a:t>
            </a:r>
            <a:r>
              <a:rPr lang="en-US" sz="46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719648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32</Words>
  <Application>Microsoft Office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re Dam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Schorey</dc:creator>
  <cp:lastModifiedBy>Jeffrey Schorey</cp:lastModifiedBy>
  <cp:revision>3</cp:revision>
  <dcterms:created xsi:type="dcterms:W3CDTF">2020-04-29T17:59:52Z</dcterms:created>
  <dcterms:modified xsi:type="dcterms:W3CDTF">2020-04-29T18:08:14Z</dcterms:modified>
</cp:coreProperties>
</file>